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2"/>
  </p:notesMasterIdLst>
  <p:sldIdLst>
    <p:sldId id="256" r:id="rId2"/>
    <p:sldId id="257" r:id="rId3"/>
    <p:sldId id="258" r:id="rId4"/>
    <p:sldId id="259" r:id="rId5"/>
    <p:sldId id="265" r:id="rId6"/>
    <p:sldId id="266" r:id="rId7"/>
    <p:sldId id="260" r:id="rId8"/>
    <p:sldId id="261" r:id="rId9"/>
    <p:sldId id="262" r:id="rId10"/>
    <p:sldId id="263" r:id="rId11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00" autoAdjust="0"/>
    <p:restoredTop sz="70415" autoAdjust="0"/>
  </p:normalViewPr>
  <p:slideViewPr>
    <p:cSldViewPr snapToGrid="0" showGuides="1">
      <p:cViewPr varScale="1">
        <p:scale>
          <a:sx n="75" d="100"/>
          <a:sy n="75" d="100"/>
        </p:scale>
        <p:origin x="960" y="5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DBE2E7-3D11-4AFF-88F5-BA9B19BBBE6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E6AD4A-0B46-4CCB-9F4C-1B6F4CBF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5938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1. </a:t>
            </a:r>
            <a:r>
              <a:rPr lang="en-US" dirty="0"/>
              <a:t>Histogram of ataxia index frequencies in DO mice. Ataxia</a:t>
            </a:r>
            <a:r>
              <a:rPr lang="en-US" baseline="0" dirty="0"/>
              <a:t> index was calculated by taking the difference between average baseline and post-ethanol performance on day 2. The distribution shows a wide range in response to 2 g/kg ethanol injection, with most animals showing increased ataxia following ethanol administration (negative values), but some animals showing decreased ataxia following ethanol administration (positive values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E6AD4A-0B46-4CCB-9F4C-1B6F4CBF843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09817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10. </a:t>
            </a:r>
            <a:r>
              <a:rPr lang="en-US" dirty="0"/>
              <a:t>Hierarchical similarity graph of shared ethanol-induced</a:t>
            </a:r>
            <a:r>
              <a:rPr lang="en-US" baseline="0" dirty="0"/>
              <a:t> LORR gene sets. Gene sets comprised positional candidates within the chromosome 2 QTL (PC_Chr2 </a:t>
            </a:r>
            <a:r>
              <a:rPr lang="en-US" baseline="0" dirty="0" err="1"/>
              <a:t>LORR.Dur.Nozeros</a:t>
            </a:r>
            <a:r>
              <a:rPr lang="en-US" baseline="0" dirty="0"/>
              <a:t>), genes with a significant cis EQTL on chromosome 2 (cis </a:t>
            </a:r>
            <a:r>
              <a:rPr lang="en-US" baseline="0" dirty="0" err="1"/>
              <a:t>eQTL</a:t>
            </a:r>
            <a:r>
              <a:rPr lang="en-US" baseline="0" dirty="0"/>
              <a:t> chr2), gene expression-trait correlations in the striatum (</a:t>
            </a:r>
            <a:r>
              <a:rPr lang="en-US" baseline="0" dirty="0" err="1"/>
              <a:t>GEX_LORR.Dur.Nozeros_STR</a:t>
            </a:r>
            <a:r>
              <a:rPr lang="en-US" baseline="0" dirty="0"/>
              <a:t>), and gene expression-trait correlations in the hippocampus (</a:t>
            </a:r>
            <a:r>
              <a:rPr lang="en-US" baseline="0" dirty="0" err="1"/>
              <a:t>GEX_LORR.Dur.Nozeros_HIPP</a:t>
            </a:r>
            <a:r>
              <a:rPr lang="en-US" baseline="0" dirty="0"/>
              <a:t>). Each box represents a set of genes completely connected to a group of gene sets. The most highly connected genes are shown in red.  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E6AD4A-0B46-4CCB-9F4C-1B6F4CBF843D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9821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2. </a:t>
            </a:r>
            <a:r>
              <a:rPr lang="en-US" dirty="0"/>
              <a:t>Histogram of average body temperature post-ethanol in DO mice. Hypothermia index was calculated by averaging the four post-ethanol temperature readings. The distribution shows a wide range of temperatures in response to 3.5 g/kg ethanol injection.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E6AD4A-0B46-4CCB-9F4C-1B6F4CBF843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01054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3. </a:t>
            </a:r>
            <a:r>
              <a:rPr lang="en-US" dirty="0"/>
              <a:t>Histogram of LORR duration post-ethanol in DO mice. The extreme values on the ends represent the 12.3% (N=96) subjects that did not lose the righting reflex and the 6.5% (N=51) that did not regain the reflex within 180 minutes following a 3.5 g/kg injection of ethanol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E6AD4A-0B46-4CCB-9F4C-1B6F4CBF843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1064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</a:t>
            </a:r>
            <a:r>
              <a:rPr lang="en-US" b="1" baseline="0" dirty="0"/>
              <a:t> Figure 4. </a:t>
            </a:r>
            <a:r>
              <a:rPr lang="en-US" baseline="0" dirty="0"/>
              <a:t>Correlations among ethanol sensitivity traits in DO mice. We observed weak, but significant correlations between traits. Ataxia and duration of LORR were negatively correlated (r(763) = -0.162, p &lt; 0.0001), ataxia and hypothermia were positively correlated (r(762) = 0.166, p &lt; 0.0001), and duration of LORR and hypothermia were negatively correlated (r(754) = -0.271, p &lt; 0.0001). The effect sizes of the correlations were small, but it is likely they were significant due to the large sample size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E6AD4A-0B46-4CCB-9F4C-1B6F4CBF843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35188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</a:t>
            </a:r>
            <a:r>
              <a:rPr lang="en-US" b="1" baseline="0" dirty="0"/>
              <a:t> Figure 5. </a:t>
            </a:r>
            <a:r>
              <a:rPr lang="en-US" b="0" dirty="0"/>
              <a:t>Motor Learning and </a:t>
            </a:r>
            <a:r>
              <a:rPr lang="en-US" dirty="0"/>
              <a:t>Ethanol-Induced</a:t>
            </a:r>
            <a:r>
              <a:rPr lang="en-US" baseline="0" dirty="0"/>
              <a:t> Ataxia in DO Mice. </a:t>
            </a:r>
            <a:r>
              <a:rPr lang="en-US" b="1" baseline="0" dirty="0"/>
              <a:t>A.</a:t>
            </a:r>
            <a:r>
              <a:rPr lang="en-US" baseline="0" dirty="0"/>
              <a:t> Repeated measures ANOVA demonstrated a significant increase in latency to fall over the course of 10 training trials, thus demonstrating that DO mice learned the motor task, </a:t>
            </a:r>
            <a:r>
              <a:rPr lang="el-GR" i="1" baseline="0" dirty="0"/>
              <a:t>F</a:t>
            </a:r>
            <a:r>
              <a:rPr lang="el-GR" baseline="0" dirty="0"/>
              <a:t>(7.2, 5651.5) = 286.5, </a:t>
            </a:r>
            <a:r>
              <a:rPr lang="el-GR" i="1" baseline="0" dirty="0"/>
              <a:t>p </a:t>
            </a:r>
            <a:r>
              <a:rPr lang="el-GR" baseline="0" dirty="0"/>
              <a:t>&lt; 0.0001, η_p^2=0.27</a:t>
            </a:r>
            <a:r>
              <a:rPr lang="en-US" baseline="0" dirty="0"/>
              <a:t>. </a:t>
            </a:r>
            <a:r>
              <a:rPr lang="en-US" b="1" baseline="0" dirty="0"/>
              <a:t>B.</a:t>
            </a:r>
            <a:r>
              <a:rPr lang="en-US" baseline="0" dirty="0"/>
              <a:t> Paired samples t-test indicated a large and significant difference in latency to fall between pre- and post-ethanol conditions, </a:t>
            </a:r>
            <a:r>
              <a:rPr lang="en-US" i="1" baseline="0" dirty="0"/>
              <a:t>t</a:t>
            </a:r>
            <a:r>
              <a:rPr lang="en-US" baseline="0" dirty="0"/>
              <a:t>(786) = 26.6, </a:t>
            </a:r>
            <a:r>
              <a:rPr lang="en-US" i="1" baseline="0" dirty="0"/>
              <a:t>p</a:t>
            </a:r>
            <a:r>
              <a:rPr lang="en-US" baseline="0" dirty="0"/>
              <a:t> &lt; 0.0001, </a:t>
            </a:r>
            <a:r>
              <a:rPr lang="en-US" i="1" baseline="0" dirty="0"/>
              <a:t>d</a:t>
            </a:r>
            <a:r>
              <a:rPr lang="en-US" baseline="0" dirty="0"/>
              <a:t> = 0.95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5F2655-AC89-4D6B-A014-9B23DF527CB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02103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</a:t>
            </a:r>
            <a:r>
              <a:rPr lang="en-US" b="1" baseline="0" dirty="0"/>
              <a:t> Figure 6. </a:t>
            </a:r>
            <a:r>
              <a:rPr lang="en-US" dirty="0"/>
              <a:t>Time course of body temperature following ethanol administration in DO mice. Baseline temperature was taken at baseline (Time 0) and four more times in 30 minute intervals. Mice</a:t>
            </a:r>
            <a:r>
              <a:rPr lang="en-US" baseline="0" dirty="0"/>
              <a:t> showed significant decreases in body temperature following ethanol administration, </a:t>
            </a:r>
            <a:r>
              <a:rPr lang="el-GR" i="1" baseline="0" dirty="0"/>
              <a:t>F</a:t>
            </a:r>
            <a:r>
              <a:rPr lang="el-GR" baseline="0" dirty="0"/>
              <a:t>(3.0, 2352.9) = 1098.3, </a:t>
            </a:r>
            <a:r>
              <a:rPr lang="el-GR" i="1" baseline="0" dirty="0"/>
              <a:t>p</a:t>
            </a:r>
            <a:r>
              <a:rPr lang="el-GR" baseline="0" dirty="0"/>
              <a:t> &lt; 0.0001, η_p^2=0.59</a:t>
            </a:r>
            <a:r>
              <a:rPr lang="en-US" baseline="0" dirty="0"/>
              <a:t>. Post-hoc pairwise comparisons indicated a significant difference between baseline temperature and each subsequent time-point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5F2655-AC89-4D6B-A014-9B23DF527CB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09076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7. </a:t>
            </a:r>
            <a:r>
              <a:rPr lang="en-US" dirty="0"/>
              <a:t>BEC in</a:t>
            </a:r>
            <a:r>
              <a:rPr lang="en-US" baseline="0" dirty="0"/>
              <a:t> DO mice. No difference in BEC between NIAAA mice that did not lose the righting reflex (N = 53) as compared to those who did (N = 157), </a:t>
            </a:r>
            <a:r>
              <a:rPr lang="en-US" i="1" baseline="0" dirty="0"/>
              <a:t>t</a:t>
            </a:r>
            <a:r>
              <a:rPr lang="en-US" baseline="0" dirty="0"/>
              <a:t>(208) = -.487, </a:t>
            </a:r>
            <a:r>
              <a:rPr lang="en-US" i="1" baseline="0" dirty="0"/>
              <a:t>p</a:t>
            </a:r>
            <a:r>
              <a:rPr lang="en-US" baseline="0" dirty="0"/>
              <a:t> = 0.627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E6AD4A-0B46-4CCB-9F4C-1B6F4CBF843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81360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8. </a:t>
            </a:r>
            <a:r>
              <a:rPr lang="en-US" dirty="0"/>
              <a:t>Hierarchical similarity graph of shared ethanol-induced</a:t>
            </a:r>
            <a:r>
              <a:rPr lang="en-US" baseline="0" dirty="0"/>
              <a:t> ataxia gene sets. Gene sets comprised positional candidates within the chromosome 16 QTL (PC_Chr16 Ataxia), genes with a significant cis EQTL on chromosome 16 (cis </a:t>
            </a:r>
            <a:r>
              <a:rPr lang="en-US" baseline="0" dirty="0" err="1"/>
              <a:t>eQTL</a:t>
            </a:r>
            <a:r>
              <a:rPr lang="en-US" baseline="0" dirty="0"/>
              <a:t> chr16), gene expression-trait correlations in the striatum (</a:t>
            </a:r>
            <a:r>
              <a:rPr lang="en-US" baseline="0" dirty="0" err="1"/>
              <a:t>GEX_Ataxia_STR</a:t>
            </a:r>
            <a:r>
              <a:rPr lang="en-US" baseline="0" dirty="0"/>
              <a:t>), and gene expression-trait correlations in the hippocampus (</a:t>
            </a:r>
            <a:r>
              <a:rPr lang="en-US" baseline="0" dirty="0" err="1"/>
              <a:t>GEX_Ataxia_HIPP</a:t>
            </a:r>
            <a:r>
              <a:rPr lang="en-US" baseline="0" dirty="0"/>
              <a:t>). Each box represents a set of genes completely connected to a group of gene sets. The most highly connected genes are shown in red.  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E6AD4A-0B46-4CCB-9F4C-1B6F4CBF843D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42148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9. </a:t>
            </a:r>
            <a:r>
              <a:rPr lang="en-US" dirty="0"/>
              <a:t>Hierarchical similarity graph of shared ethanol-induced</a:t>
            </a:r>
            <a:r>
              <a:rPr lang="en-US" baseline="0" dirty="0"/>
              <a:t> hypothermia gene sets. Gene sets comprised positional candidates within the chromosome 1 QTL (PC_Chr1 </a:t>
            </a:r>
            <a:r>
              <a:rPr lang="en-US" baseline="0" dirty="0" err="1"/>
              <a:t>AvgTempPost</a:t>
            </a:r>
            <a:r>
              <a:rPr lang="en-US" baseline="0" dirty="0"/>
              <a:t>), genes with a significant cis EQTL on chromosome 1 (cis </a:t>
            </a:r>
            <a:r>
              <a:rPr lang="en-US" baseline="0" dirty="0" err="1"/>
              <a:t>eQTL</a:t>
            </a:r>
            <a:r>
              <a:rPr lang="en-US" baseline="0" dirty="0"/>
              <a:t> chr1), gene expression-trait correlations in the striatum (</a:t>
            </a:r>
            <a:r>
              <a:rPr lang="en-US" baseline="0" dirty="0" err="1"/>
              <a:t>GEX_AvgTempPost_STR</a:t>
            </a:r>
            <a:r>
              <a:rPr lang="en-US" baseline="0" dirty="0"/>
              <a:t>), and gene expression-trait correlations in the hippocampus (</a:t>
            </a:r>
            <a:r>
              <a:rPr lang="en-US" baseline="0" dirty="0" err="1"/>
              <a:t>GEX_AvgTempPost_HIPP</a:t>
            </a:r>
            <a:r>
              <a:rPr lang="en-US" baseline="0" dirty="0"/>
              <a:t>). Each box represents a set of genes completely connected to a group of gene sets. The most highly connected genes are shown in red.  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E6AD4A-0B46-4CCB-9F4C-1B6F4CBF843D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7861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5431-0E0A-4342-8333-F26E963D4DF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5EBA5-185A-4ED9-A732-28789C7363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5807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5431-0E0A-4342-8333-F26E963D4DF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5EBA5-185A-4ED9-A732-28789C7363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0632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5431-0E0A-4342-8333-F26E963D4DF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5EBA5-185A-4ED9-A732-28789C7363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9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5431-0E0A-4342-8333-F26E963D4DF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5EBA5-185A-4ED9-A732-28789C7363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057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5431-0E0A-4342-8333-F26E963D4DF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5EBA5-185A-4ED9-A732-28789C7363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595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5431-0E0A-4342-8333-F26E963D4DF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5EBA5-185A-4ED9-A732-28789C7363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366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5431-0E0A-4342-8333-F26E963D4DF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5EBA5-185A-4ED9-A732-28789C7363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983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5431-0E0A-4342-8333-F26E963D4DF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5EBA5-185A-4ED9-A732-28789C7363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976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5431-0E0A-4342-8333-F26E963D4DF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5EBA5-185A-4ED9-A732-28789C7363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728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5431-0E0A-4342-8333-F26E963D4DF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5EBA5-185A-4ED9-A732-28789C7363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73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275431-0E0A-4342-8333-F26E963D4DF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5EBA5-185A-4ED9-A732-28789C7363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892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275431-0E0A-4342-8333-F26E963D4DF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B5EBA5-185A-4ED9-A732-28789C7363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260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04091" y="88688"/>
            <a:ext cx="4535817" cy="487722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E437BD6-07A6-467E-A07B-14BFAC50E15F}"/>
              </a:ext>
            </a:extLst>
          </p:cNvPr>
          <p:cNvSpPr txBox="1"/>
          <p:nvPr/>
        </p:nvSpPr>
        <p:spPr>
          <a:xfrm>
            <a:off x="203200" y="5047040"/>
            <a:ext cx="890270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1. </a:t>
            </a:r>
            <a:r>
              <a:rPr lang="en-US" dirty="0"/>
              <a:t>Histogram of ataxia index frequencies in DO mice. Ataxia</a:t>
            </a:r>
            <a:r>
              <a:rPr lang="en-US" baseline="0" dirty="0"/>
              <a:t> index was calculated by taking the difference between average baseline and post-ethanol performance on day 2. The distribution shows a wide range in response to 2 g/kg ethanol injection, with most animals showing increased ataxia following ethanol administration (negative values), but some animals showing decreased ataxia following ethanol administration (positive values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592235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4854" y="423863"/>
            <a:ext cx="9025663" cy="4978316"/>
            <a:chOff x="34854" y="423863"/>
            <a:chExt cx="9025663" cy="4978316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854" y="423863"/>
              <a:ext cx="9025663" cy="4978316"/>
            </a:xfrm>
            <a:prstGeom prst="rect">
              <a:avLst/>
            </a:prstGeom>
          </p:spPr>
        </p:pic>
        <p:sp>
          <p:nvSpPr>
            <p:cNvPr id="4" name="Rounded Rectangle 3"/>
            <p:cNvSpPr/>
            <p:nvPr/>
          </p:nvSpPr>
          <p:spPr>
            <a:xfrm>
              <a:off x="7591926" y="4728411"/>
              <a:ext cx="1143000" cy="469231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4689EE12-36E0-4AF3-8952-80395A525D19}"/>
              </a:ext>
            </a:extLst>
          </p:cNvPr>
          <p:cNvSpPr txBox="1"/>
          <p:nvPr/>
        </p:nvSpPr>
        <p:spPr>
          <a:xfrm>
            <a:off x="0" y="5580166"/>
            <a:ext cx="9144000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1" dirty="0"/>
              <a:t>Supplementary Figure 8. </a:t>
            </a:r>
            <a:r>
              <a:rPr lang="en-US" sz="1400" dirty="0"/>
              <a:t>Hierarchical similarity graph of shared ethanol-induced</a:t>
            </a:r>
            <a:r>
              <a:rPr lang="en-US" sz="1400" baseline="0" dirty="0"/>
              <a:t> LORR gene sets. Gene sets comprised positional candidates within the chromosome 2 QTL (PC_Chr2 </a:t>
            </a:r>
            <a:r>
              <a:rPr lang="en-US" sz="1400" baseline="0" dirty="0" err="1"/>
              <a:t>LORR.Dur.Nozeros</a:t>
            </a:r>
            <a:r>
              <a:rPr lang="en-US" sz="1400" baseline="0" dirty="0"/>
              <a:t>), genes with a significant cis EQTL on chromosome 2 (cis </a:t>
            </a:r>
            <a:r>
              <a:rPr lang="en-US" sz="1400" baseline="0" dirty="0" err="1"/>
              <a:t>eQTL</a:t>
            </a:r>
            <a:r>
              <a:rPr lang="en-US" sz="1400" baseline="0" dirty="0"/>
              <a:t> chr2), gene expression-trait correlations in the striatum (</a:t>
            </a:r>
            <a:r>
              <a:rPr lang="en-US" sz="1400" baseline="0" dirty="0" err="1"/>
              <a:t>GEX_LORR.Dur.Nozeros_STR</a:t>
            </a:r>
            <a:r>
              <a:rPr lang="en-US" sz="1400" baseline="0" dirty="0"/>
              <a:t>), and gene expression-trait correlations in the hippocampus (</a:t>
            </a:r>
            <a:r>
              <a:rPr lang="en-US" sz="1400" baseline="0" dirty="0" err="1"/>
              <a:t>GEX_LORR.Dur.Nozeros_HIPP</a:t>
            </a:r>
            <a:r>
              <a:rPr lang="en-US" sz="1400" baseline="0" dirty="0"/>
              <a:t>). Each box represents a set of genes completely connected to a group of gene sets. The most highly connected genes are shown in red. 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9073246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r="22768"/>
          <a:stretch/>
        </p:blipFill>
        <p:spPr>
          <a:xfrm>
            <a:off x="1571223" y="899912"/>
            <a:ext cx="5975797" cy="48006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013652" y="5306095"/>
            <a:ext cx="400532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b="1" dirty="0"/>
              <a:t>Average Temperature Post-Ethanol (°C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97F0C7-C7FB-48E0-BF7A-44920934CE63}"/>
              </a:ext>
            </a:extLst>
          </p:cNvPr>
          <p:cNvSpPr txBox="1"/>
          <p:nvPr/>
        </p:nvSpPr>
        <p:spPr>
          <a:xfrm>
            <a:off x="63500" y="5815149"/>
            <a:ext cx="90170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. </a:t>
            </a:r>
            <a:r>
              <a:rPr lang="en-US" dirty="0"/>
              <a:t>Histogram of average body temperature post-ethanol in DO mice. Hypothermia index was calculated by averaging the four post-ethanol temperature readings. The distribution shows a wide range of temperatures in response to 3.5 g/kg ethanol injection.</a:t>
            </a:r>
          </a:p>
        </p:txBody>
      </p:sp>
    </p:spTree>
    <p:extLst>
      <p:ext uri="{BB962C8B-B14F-4D97-AF65-F5344CB8AC3E}">
        <p14:creationId xmlns:p14="http://schemas.microsoft.com/office/powerpoint/2010/main" val="4267818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r="21383"/>
          <a:stretch/>
        </p:blipFill>
        <p:spPr>
          <a:xfrm>
            <a:off x="1576387" y="57170"/>
            <a:ext cx="5489545" cy="559500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7B5C5F7-7C88-4D77-8D20-2AE2CC7B2798}"/>
              </a:ext>
            </a:extLst>
          </p:cNvPr>
          <p:cNvSpPr txBox="1"/>
          <p:nvPr/>
        </p:nvSpPr>
        <p:spPr>
          <a:xfrm>
            <a:off x="0" y="5652175"/>
            <a:ext cx="91440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3. </a:t>
            </a:r>
            <a:r>
              <a:rPr lang="en-US" dirty="0"/>
              <a:t>Histogram of LORR duration post-ethanol in DO mice. The extreme values on the ends represent the 12.3% (N=96) subjects that did not lose the righting reflex and the 6.5% (N=51) that did not regain the reflex within 180 minutes following a 3.5 g/kg injection of ethanol.</a:t>
            </a:r>
          </a:p>
        </p:txBody>
      </p:sp>
    </p:spTree>
    <p:extLst>
      <p:ext uri="{BB962C8B-B14F-4D97-AF65-F5344CB8AC3E}">
        <p14:creationId xmlns:p14="http://schemas.microsoft.com/office/powerpoint/2010/main" val="31042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028700" y="0"/>
            <a:ext cx="6616700" cy="5207000"/>
            <a:chOff x="839410" y="990600"/>
            <a:chExt cx="7161590" cy="5738381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39410" y="990600"/>
              <a:ext cx="7161590" cy="5738381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2133600" y="2819400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r = 0.166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133600" y="4514850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r = -0.162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810000" y="4514850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r = -0.271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486400" y="2818775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r = -0.271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943600" y="1009650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r = -0.162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429000" y="1009650"/>
              <a:ext cx="1447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r = 0.166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31EC1D95-5CF2-43EA-BA77-8A4939EC110C}"/>
              </a:ext>
            </a:extLst>
          </p:cNvPr>
          <p:cNvSpPr txBox="1"/>
          <p:nvPr/>
        </p:nvSpPr>
        <p:spPr>
          <a:xfrm>
            <a:off x="0" y="5459274"/>
            <a:ext cx="9144000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/>
              <a:t>Supplementary</a:t>
            </a:r>
            <a:r>
              <a:rPr lang="en-US" sz="1600" b="1" baseline="0" dirty="0"/>
              <a:t> Figure 4. </a:t>
            </a:r>
            <a:r>
              <a:rPr lang="en-US" sz="1600" baseline="0" dirty="0"/>
              <a:t>Correlations among ethanol sensitivity traits in DO mice. We observed weak, but significant correlations between traits. Ataxia and duration of LORR were negatively correlated (r(763) = -0.162, p &lt; 0.0001), ataxia and hypothermia were positively correlated (r(762) = 0.166, p &lt; 0.0001), and duration of LORR and hypothermia were negatively correlated (r(754) = -0.271, p &lt; 0.0001). The effect sizes of the correlations were small, but it is likely they were significant due to the large sample size.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6562492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29576" y="1509855"/>
            <a:ext cx="4185634" cy="334419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31074" y="1123406"/>
            <a:ext cx="4180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220798" y="1119050"/>
            <a:ext cx="4180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440" y="1488382"/>
            <a:ext cx="4521291" cy="33798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35307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604513" y="1048532"/>
            <a:ext cx="5934973" cy="5130267"/>
            <a:chOff x="1604513" y="1048532"/>
            <a:chExt cx="5934973" cy="5130267"/>
          </a:xfrm>
        </p:grpSpPr>
        <p:grpSp>
          <p:nvGrpSpPr>
            <p:cNvPr id="4" name="Group 3"/>
            <p:cNvGrpSpPr/>
            <p:nvPr/>
          </p:nvGrpSpPr>
          <p:grpSpPr>
            <a:xfrm>
              <a:off x="1604513" y="1048532"/>
              <a:ext cx="5934973" cy="4760935"/>
              <a:chOff x="1604513" y="1048532"/>
              <a:chExt cx="5934973" cy="4760935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604513" y="1048532"/>
                <a:ext cx="5934973" cy="4760935"/>
              </a:xfrm>
              <a:prstGeom prst="rect">
                <a:avLst/>
              </a:prstGeom>
            </p:spPr>
          </p:pic>
          <p:sp>
            <p:nvSpPr>
              <p:cNvPr id="3" name="TextBox 2"/>
              <p:cNvSpPr txBox="1"/>
              <p:nvPr/>
            </p:nvSpPr>
            <p:spPr>
              <a:xfrm rot="16200000">
                <a:off x="323634" y="2956142"/>
                <a:ext cx="2931090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Temperature (°C)</a:t>
                </a:r>
              </a:p>
            </p:txBody>
          </p:sp>
        </p:grpSp>
        <p:sp>
          <p:nvSpPr>
            <p:cNvPr id="5" name="TextBox 4"/>
            <p:cNvSpPr txBox="1"/>
            <p:nvPr/>
          </p:nvSpPr>
          <p:spPr>
            <a:xfrm>
              <a:off x="3006671" y="5809467"/>
              <a:ext cx="37815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Time (min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106169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6387" y="1028700"/>
            <a:ext cx="5991225" cy="48006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DB0E27E-8A77-42FB-8AEC-DB20DF4C71C2}"/>
              </a:ext>
            </a:extLst>
          </p:cNvPr>
          <p:cNvSpPr txBox="1"/>
          <p:nvPr/>
        </p:nvSpPr>
        <p:spPr>
          <a:xfrm>
            <a:off x="0" y="5875972"/>
            <a:ext cx="91440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5. </a:t>
            </a:r>
            <a:r>
              <a:rPr lang="en-US" dirty="0"/>
              <a:t>BEC in</a:t>
            </a:r>
            <a:r>
              <a:rPr lang="en-US" baseline="0" dirty="0"/>
              <a:t> DO mice. No difference in BEC between NIAAA mice that did not lose the righting reflex (N = 53) as compared to those who did (N = 157), </a:t>
            </a:r>
            <a:r>
              <a:rPr lang="en-US" i="1" baseline="0" dirty="0"/>
              <a:t>t</a:t>
            </a:r>
            <a:r>
              <a:rPr lang="en-US" baseline="0" dirty="0"/>
              <a:t>(208) = -.487, </a:t>
            </a:r>
            <a:r>
              <a:rPr lang="en-US" i="1" baseline="0" dirty="0"/>
              <a:t>p</a:t>
            </a:r>
            <a:r>
              <a:rPr lang="en-US" baseline="0" dirty="0"/>
              <a:t> = 0.627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02309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141" y="471488"/>
            <a:ext cx="9099555" cy="4969942"/>
            <a:chOff x="9141" y="471488"/>
            <a:chExt cx="9099555" cy="496994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141" y="471488"/>
              <a:ext cx="9099555" cy="4969942"/>
            </a:xfrm>
            <a:prstGeom prst="rect">
              <a:avLst/>
            </a:prstGeom>
          </p:spPr>
        </p:pic>
        <p:sp>
          <p:nvSpPr>
            <p:cNvPr id="4" name="Rectangle 3"/>
            <p:cNvSpPr/>
            <p:nvPr/>
          </p:nvSpPr>
          <p:spPr>
            <a:xfrm>
              <a:off x="7612083" y="4762005"/>
              <a:ext cx="1211283" cy="51063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0B415348-40D8-4C1F-BCF7-4119B907BF81}"/>
              </a:ext>
            </a:extLst>
          </p:cNvPr>
          <p:cNvSpPr txBox="1"/>
          <p:nvPr/>
        </p:nvSpPr>
        <p:spPr>
          <a:xfrm>
            <a:off x="101600" y="5532864"/>
            <a:ext cx="8943596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1" dirty="0"/>
              <a:t>Supplementary Figure 6. </a:t>
            </a:r>
            <a:r>
              <a:rPr lang="en-US" sz="1400" dirty="0"/>
              <a:t>Hierarchical similarity graph of shared ethanol-induced</a:t>
            </a:r>
            <a:r>
              <a:rPr lang="en-US" sz="1400" baseline="0" dirty="0"/>
              <a:t> ataxia gene sets. Gene sets comprised positional candidates within the chromosome 16 QTL (PC_Chr16 Ataxia), genes with a significant cis EQTL on chromosome 16 (cis </a:t>
            </a:r>
            <a:r>
              <a:rPr lang="en-US" sz="1400" baseline="0" dirty="0" err="1"/>
              <a:t>eQTL</a:t>
            </a:r>
            <a:r>
              <a:rPr lang="en-US" sz="1400" baseline="0" dirty="0"/>
              <a:t> chr16), gene expression-trait correlations in the striatum (</a:t>
            </a:r>
            <a:r>
              <a:rPr lang="en-US" sz="1400" baseline="0" dirty="0" err="1"/>
              <a:t>GEX_Ataxia_STR</a:t>
            </a:r>
            <a:r>
              <a:rPr lang="en-US" sz="1400" baseline="0" dirty="0"/>
              <a:t>), and gene expression-trait correlations in the hippocampus (</a:t>
            </a:r>
            <a:r>
              <a:rPr lang="en-US" sz="1400" baseline="0" dirty="0" err="1"/>
              <a:t>GEX_Ataxia_HIPP</a:t>
            </a:r>
            <a:r>
              <a:rPr lang="en-US" sz="1400" baseline="0" dirty="0"/>
              <a:t>). Each box represents a set of genes completely connected to a group of gene sets. The most highly connected genes are shown in red. 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3409629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2493" y="485775"/>
            <a:ext cx="9010958" cy="5048751"/>
            <a:chOff x="62493" y="485775"/>
            <a:chExt cx="9010958" cy="5048751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2493" y="485775"/>
              <a:ext cx="9010958" cy="5048751"/>
            </a:xfrm>
            <a:prstGeom prst="rect">
              <a:avLst/>
            </a:prstGeom>
          </p:spPr>
        </p:pic>
        <p:sp>
          <p:nvSpPr>
            <p:cNvPr id="4" name="Rounded Rectangle 3"/>
            <p:cNvSpPr/>
            <p:nvPr/>
          </p:nvSpPr>
          <p:spPr>
            <a:xfrm>
              <a:off x="7772400" y="4848726"/>
              <a:ext cx="1167063" cy="553453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F70A6B21-16C9-49F4-92AA-2207B99F0E12}"/>
              </a:ext>
            </a:extLst>
          </p:cNvPr>
          <p:cNvSpPr txBox="1"/>
          <p:nvPr/>
        </p:nvSpPr>
        <p:spPr>
          <a:xfrm>
            <a:off x="-1" y="5595541"/>
            <a:ext cx="9081507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1" dirty="0"/>
              <a:t>Supplementary Figure 7. </a:t>
            </a:r>
            <a:r>
              <a:rPr lang="en-US" sz="1400" dirty="0"/>
              <a:t>Hierarchical similarity graph of shared ethanol-induced</a:t>
            </a:r>
            <a:r>
              <a:rPr lang="en-US" sz="1400" baseline="0" dirty="0"/>
              <a:t> hypothermia gene sets. Gene sets comprised positional candidates within the chromosome 1 QTL (PC_Chr1 </a:t>
            </a:r>
            <a:r>
              <a:rPr lang="en-US" sz="1400" baseline="0" dirty="0" err="1"/>
              <a:t>AvgTempPost</a:t>
            </a:r>
            <a:r>
              <a:rPr lang="en-US" sz="1400" baseline="0" dirty="0"/>
              <a:t>), genes with a significant cis EQTL on chromosome 1 (cis </a:t>
            </a:r>
            <a:r>
              <a:rPr lang="en-US" sz="1400" baseline="0" dirty="0" err="1"/>
              <a:t>eQTL</a:t>
            </a:r>
            <a:r>
              <a:rPr lang="en-US" sz="1400" baseline="0" dirty="0"/>
              <a:t> chr1), gene expression-trait correlations in the striatum (</a:t>
            </a:r>
            <a:r>
              <a:rPr lang="en-US" sz="1400" baseline="0" dirty="0" err="1"/>
              <a:t>GEX_AvgTempPost_STR</a:t>
            </a:r>
            <a:r>
              <a:rPr lang="en-US" sz="1400" baseline="0" dirty="0"/>
              <a:t>), and gene expression-trait correlations in the hippocampus (</a:t>
            </a:r>
            <a:r>
              <a:rPr lang="en-US" sz="1400" baseline="0" dirty="0" err="1"/>
              <a:t>GEX_AvgTempPost_HIPP</a:t>
            </a:r>
            <a:r>
              <a:rPr lang="en-US" sz="1400" baseline="0" dirty="0"/>
              <a:t>). Each box represents a set of genes completely connected to a group of gene sets. The most highly connected genes are shown in red. 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23271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9</TotalTime>
  <Words>1511</Words>
  <Application>Microsoft Office PowerPoint</Application>
  <PresentationFormat>On-screen Show (4:3)</PresentationFormat>
  <Paragraphs>40</Paragraphs>
  <Slides>10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ddlebury Colle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ker, Clarissa C.</dc:creator>
  <cp:lastModifiedBy>Parker, Clarissa C.</cp:lastModifiedBy>
  <cp:revision>10</cp:revision>
  <dcterms:created xsi:type="dcterms:W3CDTF">2019-10-23T18:01:18Z</dcterms:created>
  <dcterms:modified xsi:type="dcterms:W3CDTF">2021-08-30T18:06:00Z</dcterms:modified>
</cp:coreProperties>
</file>